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6858000" cy="9144000" type="screen4x3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71" userDrawn="1">
          <p15:clr>
            <a:srgbClr val="A4A3A4"/>
          </p15:clr>
        </p15:guide>
        <p15:guide id="2" pos="361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0D54E17-9C36-29A9-6633-520DD30B5982}" name="Yuji Kibe" initials="YK" userId="f5228f417efc0f44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3C2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4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1866" y="57"/>
      </p:cViewPr>
      <p:guideLst>
        <p:guide orient="horz" pos="2971"/>
        <p:guide pos="36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78428" cy="513508"/>
          </a:xfrm>
          <a:prstGeom prst="rect">
            <a:avLst/>
          </a:prstGeom>
        </p:spPr>
        <p:txBody>
          <a:bodyPr vert="horz" lIns="94657" tIns="47329" rIns="94657" bIns="4732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3" y="2"/>
            <a:ext cx="3078428" cy="513508"/>
          </a:xfrm>
          <a:prstGeom prst="rect">
            <a:avLst/>
          </a:prstGeom>
        </p:spPr>
        <p:txBody>
          <a:bodyPr vert="horz" lIns="94657" tIns="47329" rIns="94657" bIns="47329" rtlCol="0"/>
          <a:lstStyle>
            <a:lvl1pPr algn="r">
              <a:defRPr sz="1200"/>
            </a:lvl1pPr>
          </a:lstStyle>
          <a:p>
            <a:fld id="{08AC1FEF-6248-48EF-ADC7-7323A18EE66D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55838" y="1279525"/>
            <a:ext cx="25923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57" tIns="47329" rIns="94657" bIns="4732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925409"/>
            <a:ext cx="5683250" cy="4029879"/>
          </a:xfrm>
          <a:prstGeom prst="rect">
            <a:avLst/>
          </a:prstGeom>
        </p:spPr>
        <p:txBody>
          <a:bodyPr vert="horz" lIns="94657" tIns="47329" rIns="94657" bIns="4732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721108"/>
            <a:ext cx="3078428" cy="513507"/>
          </a:xfrm>
          <a:prstGeom prst="rect">
            <a:avLst/>
          </a:prstGeom>
        </p:spPr>
        <p:txBody>
          <a:bodyPr vert="horz" lIns="94657" tIns="47329" rIns="94657" bIns="4732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3" y="9721108"/>
            <a:ext cx="3078428" cy="513507"/>
          </a:xfrm>
          <a:prstGeom prst="rect">
            <a:avLst/>
          </a:prstGeom>
        </p:spPr>
        <p:txBody>
          <a:bodyPr vert="horz" lIns="94657" tIns="47329" rIns="94657" bIns="47329" rtlCol="0" anchor="b"/>
          <a:lstStyle>
            <a:lvl1pPr algn="r">
              <a:defRPr sz="1200"/>
            </a:lvl1pPr>
          </a:lstStyle>
          <a:p>
            <a:fld id="{37172A37-B75A-41AB-B70E-749BAD984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381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717E4F-790A-0FC4-A825-05A1056C1C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D6DDD19-9EBA-943D-F57B-0B006FD4F29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4493256-EB52-8E23-56C9-227470DE3F7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F8FC8F9-5CF5-9687-7DB0-1BB7680DC45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172A37-B75A-41AB-B70E-749BAD98416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995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01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144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722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36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028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413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441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144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23042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88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769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75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D094D-99CF-4F6C-9822-CB2F59D3FD4F}" type="datetimeFigureOut">
              <a:rPr kumimoji="1" lang="ja-JP" altLang="en-US" smtClean="0"/>
              <a:t>2025/4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08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AC12D2-06D5-3FDD-77DE-016ECB58D6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3330209B-CEDD-68A4-69A8-4285976EA7F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786" t="7362" r="25152" b="11619"/>
          <a:stretch/>
        </p:blipFill>
        <p:spPr>
          <a:xfrm>
            <a:off x="716201" y="970243"/>
            <a:ext cx="4534457" cy="323040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DCED690-0BBC-E0AA-B541-DEEA3FCC443A}"/>
              </a:ext>
            </a:extLst>
          </p:cNvPr>
          <p:cNvSpPr txBox="1"/>
          <p:nvPr/>
        </p:nvSpPr>
        <p:spPr>
          <a:xfrm>
            <a:off x="134112" y="132326"/>
            <a:ext cx="3013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Supplementary Fig.1</a:t>
            </a:r>
            <a:endParaRPr kumimoji="1" lang="ja-JP" altLang="en-US" b="1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791F9AD5-6E76-715E-63C5-2AD6BF5228C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431" t="8517" r="92353" b="8564"/>
          <a:stretch/>
        </p:blipFill>
        <p:spPr>
          <a:xfrm>
            <a:off x="568381" y="1051209"/>
            <a:ext cx="147821" cy="325918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53B942A-07B6-AA33-C7E8-58CB00E9390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424" t="88128" r="23715" b="8564"/>
          <a:stretch/>
        </p:blipFill>
        <p:spPr>
          <a:xfrm>
            <a:off x="574205" y="4200652"/>
            <a:ext cx="4726905" cy="13005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69014B7-A905-A0FD-135F-557521AC071C}"/>
              </a:ext>
            </a:extLst>
          </p:cNvPr>
          <p:cNvSpPr txBox="1"/>
          <p:nvPr/>
        </p:nvSpPr>
        <p:spPr>
          <a:xfrm>
            <a:off x="5162262" y="1108341"/>
            <a:ext cx="1415772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Distant </a:t>
            </a:r>
          </a:p>
          <a:p>
            <a:pPr algn="ctr"/>
            <a:r>
              <a:rPr kumimoji="1" lang="en-US" altLang="ja-JP" sz="1600" dirty="0"/>
              <a:t>parenchymal </a:t>
            </a:r>
          </a:p>
          <a:p>
            <a:pPr algn="ctr"/>
            <a:r>
              <a:rPr kumimoji="1" lang="en-US" altLang="ja-JP" sz="1600" dirty="0"/>
              <a:t>recurrence</a:t>
            </a: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AD9B21C7-E2C9-C3F1-F9DE-EFEEC87045E3}"/>
              </a:ext>
            </a:extLst>
          </p:cNvPr>
          <p:cNvCxnSpPr>
            <a:cxnSpLocks/>
            <a:endCxn id="17" idx="1"/>
          </p:cNvCxnSpPr>
          <p:nvPr/>
        </p:nvCxnSpPr>
        <p:spPr>
          <a:xfrm>
            <a:off x="5422517" y="2134118"/>
            <a:ext cx="378519" cy="0"/>
          </a:xfrm>
          <a:prstGeom prst="line">
            <a:avLst/>
          </a:prstGeom>
          <a:ln w="28575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4FBE4EE-3CFC-C73D-CFE2-B55E0D1C7193}"/>
              </a:ext>
            </a:extLst>
          </p:cNvPr>
          <p:cNvCxnSpPr>
            <a:cxnSpLocks/>
            <a:endCxn id="17" idx="1"/>
          </p:cNvCxnSpPr>
          <p:nvPr/>
        </p:nvCxnSpPr>
        <p:spPr>
          <a:xfrm>
            <a:off x="5422517" y="2483221"/>
            <a:ext cx="378519" cy="0"/>
          </a:xfrm>
          <a:prstGeom prst="line">
            <a:avLst/>
          </a:prstGeom>
          <a:ln w="285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76864A7-DA96-412B-2A8D-70DB69B812AD}"/>
              </a:ext>
            </a:extLst>
          </p:cNvPr>
          <p:cNvSpPr txBox="1"/>
          <p:nvPr/>
        </p:nvSpPr>
        <p:spPr>
          <a:xfrm>
            <a:off x="5801036" y="1939338"/>
            <a:ext cx="605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No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82BA7E8-935E-49B4-FA90-F9F9D43A8E2C}"/>
              </a:ext>
            </a:extLst>
          </p:cNvPr>
          <p:cNvSpPr txBox="1"/>
          <p:nvPr/>
        </p:nvSpPr>
        <p:spPr>
          <a:xfrm>
            <a:off x="5801036" y="2298555"/>
            <a:ext cx="707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Yes</a:t>
            </a:r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3190997-3434-E1BC-206D-AAE3A374C7EC}"/>
              </a:ext>
            </a:extLst>
          </p:cNvPr>
          <p:cNvSpPr txBox="1"/>
          <p:nvPr/>
        </p:nvSpPr>
        <p:spPr>
          <a:xfrm>
            <a:off x="2469772" y="4310390"/>
            <a:ext cx="107652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/>
              <a:t>Time (Days)</a:t>
            </a:r>
            <a:endParaRPr kumimoji="1" lang="ja-JP" altLang="en-US" sz="110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F1531DB-C6A4-64CA-22B7-3E7F81179281}"/>
              </a:ext>
            </a:extLst>
          </p:cNvPr>
          <p:cNvSpPr txBox="1"/>
          <p:nvPr/>
        </p:nvSpPr>
        <p:spPr>
          <a:xfrm>
            <a:off x="215231" y="1535860"/>
            <a:ext cx="353943" cy="2110567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r>
              <a:rPr kumimoji="1" lang="en-US" altLang="ja-JP" sz="1100" b="1" dirty="0"/>
              <a:t>Probability of Overall survival</a:t>
            </a:r>
            <a:endParaRPr kumimoji="1" lang="ja-JP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141159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840</TotalTime>
  <Words>18</Words>
  <Application>Microsoft Office PowerPoint</Application>
  <PresentationFormat>画面に合わせる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ido</dc:creator>
  <cp:lastModifiedBy>史治 大岡</cp:lastModifiedBy>
  <cp:revision>21</cp:revision>
  <cp:lastPrinted>2024-03-22T03:49:43Z</cp:lastPrinted>
  <dcterms:created xsi:type="dcterms:W3CDTF">2023-08-04T15:13:22Z</dcterms:created>
  <dcterms:modified xsi:type="dcterms:W3CDTF">2025-04-10T04:08:42Z</dcterms:modified>
</cp:coreProperties>
</file>